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0" d="100"/>
          <a:sy n="60" d="100"/>
        </p:scale>
        <p:origin x="-2582" y="-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893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286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017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25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773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008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457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679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161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388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523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B45884-2B9A-4E0F-B7E4-824582D4EBC6}" type="datetimeFigureOut">
              <a:rPr lang="en-US" smtClean="0"/>
              <a:t>7/2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B3729-93F1-4EAD-8A51-C93BEDC875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460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t="695" r="1036" b="2122"/>
          <a:stretch/>
        </p:blipFill>
        <p:spPr bwMode="auto">
          <a:xfrm>
            <a:off x="646734" y="154339"/>
            <a:ext cx="2743200" cy="19762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t="695" r="1036" b="2122"/>
          <a:stretch/>
        </p:blipFill>
        <p:spPr bwMode="auto">
          <a:xfrm>
            <a:off x="646734" y="2364139"/>
            <a:ext cx="2743200" cy="19762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t="695" r="1036" b="2122"/>
          <a:stretch/>
        </p:blipFill>
        <p:spPr bwMode="auto">
          <a:xfrm>
            <a:off x="3910840" y="6834539"/>
            <a:ext cx="2743200" cy="19762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" t="695" r="1036" b="2122"/>
          <a:stretch/>
        </p:blipFill>
        <p:spPr bwMode="auto">
          <a:xfrm>
            <a:off x="646734" y="4642626"/>
            <a:ext cx="2743200" cy="19762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172621" y="8836223"/>
            <a:ext cx="1691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election population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239812" y="500676"/>
            <a:ext cx="400110" cy="138749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Night sleep (min.)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3403009" y="577367"/>
            <a:ext cx="400110" cy="1267206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Day sleep (min.)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403009" y="2666580"/>
            <a:ext cx="400110" cy="137140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Day bout number</a:t>
            </a:r>
            <a:endParaRPr lang="en-US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229115" y="2606436"/>
            <a:ext cx="400110" cy="149169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Night bout number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3295287" y="5108092"/>
            <a:ext cx="615553" cy="11255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400" dirty="0" smtClean="0"/>
              <a:t>Day avg. bout </a:t>
            </a:r>
          </a:p>
          <a:p>
            <a:pPr algn="ctr"/>
            <a:r>
              <a:rPr lang="en-US" sz="1400" dirty="0" smtClean="0"/>
              <a:t>length (min.)</a:t>
            </a:r>
            <a:endParaRPr lang="en-US" sz="1400" dirty="0"/>
          </a:p>
        </p:txBody>
      </p:sp>
      <p:sp>
        <p:nvSpPr>
          <p:cNvPr id="24" name="TextBox 23"/>
          <p:cNvSpPr txBox="1"/>
          <p:nvPr/>
        </p:nvSpPr>
        <p:spPr>
          <a:xfrm>
            <a:off x="75387" y="5027878"/>
            <a:ext cx="615553" cy="120577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sz="1400" dirty="0" smtClean="0"/>
              <a:t>Night avg. bout</a:t>
            </a:r>
          </a:p>
          <a:p>
            <a:pPr algn="ctr"/>
            <a:r>
              <a:rPr lang="en-US" sz="1400" dirty="0" smtClean="0"/>
              <a:t>length (min.)</a:t>
            </a:r>
            <a:endParaRPr lang="en-US" sz="1400" dirty="0"/>
          </a:p>
        </p:txBody>
      </p:sp>
      <p:sp>
        <p:nvSpPr>
          <p:cNvPr id="9" name="TextBox 8"/>
          <p:cNvSpPr txBox="1"/>
          <p:nvPr/>
        </p:nvSpPr>
        <p:spPr>
          <a:xfrm>
            <a:off x="3503918" y="6817367"/>
            <a:ext cx="400110" cy="19552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Waking activity (</a:t>
            </a:r>
            <a:r>
              <a:rPr lang="en-US" sz="1400" dirty="0" err="1" smtClean="0"/>
              <a:t>cts</a:t>
            </a:r>
            <a:r>
              <a:rPr lang="en-US" sz="1400" dirty="0" smtClean="0"/>
              <a:t>/min.)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281009" y="849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3444206" y="849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229115" y="232899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92312" y="232899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281009" y="438912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444206" y="438912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22206" y="649224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41248" y="181679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</a:t>
            </a:r>
            <a:r>
              <a:rPr lang="en-US" sz="1400" dirty="0" smtClean="0"/>
              <a:t> = ns</a:t>
            </a:r>
            <a:endParaRPr lang="en-US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841248" y="2390553"/>
            <a:ext cx="949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</a:t>
            </a:r>
            <a:r>
              <a:rPr lang="en-US" sz="1400" dirty="0" smtClean="0"/>
              <a:t> = 0.0157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841248" y="4654733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</a:t>
            </a:r>
            <a:r>
              <a:rPr lang="en-US" sz="1400" dirty="0" smtClean="0"/>
              <a:t> = ns</a:t>
            </a:r>
            <a:endParaRPr lang="en-US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4436727" y="8828710"/>
            <a:ext cx="1691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election population</a:t>
            </a:r>
            <a:endParaRPr lang="en-US" sz="1400" dirty="0"/>
          </a:p>
        </p:txBody>
      </p:sp>
      <p:grpSp>
        <p:nvGrpSpPr>
          <p:cNvPr id="2" name="Group 1"/>
          <p:cNvGrpSpPr/>
          <p:nvPr/>
        </p:nvGrpSpPr>
        <p:grpSpPr>
          <a:xfrm>
            <a:off x="3840480" y="154339"/>
            <a:ext cx="2743200" cy="6464571"/>
            <a:chOff x="3733800" y="154339"/>
            <a:chExt cx="2743200" cy="6464571"/>
          </a:xfrm>
        </p:grpSpPr>
        <p:pic>
          <p:nvPicPr>
            <p:cNvPr id="1031" name="Picture 7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4" t="695" r="1036" b="2122"/>
            <a:stretch/>
          </p:blipFill>
          <p:spPr bwMode="auto">
            <a:xfrm>
              <a:off x="3733800" y="2364139"/>
              <a:ext cx="2743200" cy="19762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3" name="Picture 9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4" t="695" r="1036" b="2122"/>
            <a:stretch/>
          </p:blipFill>
          <p:spPr bwMode="auto">
            <a:xfrm>
              <a:off x="3733800" y="4642626"/>
              <a:ext cx="2743200" cy="19762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6" name="Picture 12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4" t="695" r="1036" b="2122"/>
            <a:stretch/>
          </p:blipFill>
          <p:spPr bwMode="auto">
            <a:xfrm>
              <a:off x="3733800" y="154339"/>
              <a:ext cx="2743200" cy="19762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" name="TextBox 34"/>
            <p:cNvSpPr txBox="1"/>
            <p:nvPr/>
          </p:nvSpPr>
          <p:spPr>
            <a:xfrm>
              <a:off x="4096094" y="26959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smtClean="0"/>
                <a:t>P</a:t>
              </a:r>
              <a:r>
                <a:rPr lang="en-US" sz="1400" dirty="0" smtClean="0"/>
                <a:t> = ns</a:t>
              </a:r>
              <a:endParaRPr lang="en-US" sz="14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100235" y="2340447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smtClean="0"/>
                <a:t>P</a:t>
              </a:r>
              <a:r>
                <a:rPr lang="en-US" sz="1400" dirty="0" smtClean="0"/>
                <a:t> = ns</a:t>
              </a:r>
              <a:endParaRPr lang="en-US" sz="1400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117255" y="467863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smtClean="0"/>
                <a:t>P</a:t>
              </a:r>
              <a:r>
                <a:rPr lang="en-US" sz="1400" dirty="0" smtClean="0"/>
                <a:t> = ns</a:t>
              </a:r>
              <a:endParaRPr lang="en-US" sz="1400" dirty="0"/>
            </a:p>
          </p:txBody>
        </p:sp>
      </p:grpSp>
      <p:sp>
        <p:nvSpPr>
          <p:cNvPr id="40" name="TextBox 39"/>
          <p:cNvSpPr txBox="1"/>
          <p:nvPr/>
        </p:nvSpPr>
        <p:spPr>
          <a:xfrm>
            <a:off x="4105354" y="6882028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</a:t>
            </a:r>
            <a:r>
              <a:rPr lang="en-US" sz="1400" dirty="0" smtClean="0"/>
              <a:t> = ns</a:t>
            </a:r>
            <a:endParaRPr lang="en-US" sz="1400" dirty="0"/>
          </a:p>
        </p:txBody>
      </p:sp>
      <p:sp>
        <p:nvSpPr>
          <p:cNvPr id="41" name="TextBox 40"/>
          <p:cNvSpPr txBox="1"/>
          <p:nvPr/>
        </p:nvSpPr>
        <p:spPr>
          <a:xfrm>
            <a:off x="3553086" y="649224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7" t="695" r="1631" b="670"/>
          <a:stretch/>
        </p:blipFill>
        <p:spPr bwMode="auto">
          <a:xfrm>
            <a:off x="665273" y="6787203"/>
            <a:ext cx="2697480" cy="1984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2" name="TextBox 41"/>
          <p:cNvSpPr txBox="1"/>
          <p:nvPr/>
        </p:nvSpPr>
        <p:spPr>
          <a:xfrm>
            <a:off x="203537" y="6880870"/>
            <a:ext cx="400110" cy="152984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400" dirty="0" smtClean="0"/>
              <a:t>Sleep latency (min</a:t>
            </a:r>
            <a:r>
              <a:rPr lang="en-US" sz="1400" dirty="0" smtClean="0"/>
              <a:t>.)</a:t>
            </a:r>
            <a:endParaRPr lang="en-US" sz="1400" dirty="0"/>
          </a:p>
        </p:txBody>
      </p:sp>
      <p:sp>
        <p:nvSpPr>
          <p:cNvPr id="43" name="TextBox 42"/>
          <p:cNvSpPr txBox="1"/>
          <p:nvPr/>
        </p:nvSpPr>
        <p:spPr>
          <a:xfrm>
            <a:off x="866287" y="6861572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P</a:t>
            </a:r>
            <a:r>
              <a:rPr lang="en-US" sz="1400" dirty="0" smtClean="0"/>
              <a:t> = ns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7639704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5</TotalTime>
  <Words>78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HLB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bison, Susan (NIH/NHLBI) [E]</dc:creator>
  <cp:lastModifiedBy>Harbison, Susan (NIH/NHLBI) [E]</cp:lastModifiedBy>
  <cp:revision>11</cp:revision>
  <dcterms:created xsi:type="dcterms:W3CDTF">2013-08-06T16:28:22Z</dcterms:created>
  <dcterms:modified xsi:type="dcterms:W3CDTF">2016-07-28T14:45:58Z</dcterms:modified>
</cp:coreProperties>
</file>